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56" r:id="rId1"/>
  </p:sldMasterIdLst>
  <p:sldIdLst>
    <p:sldId id="311" r:id="rId2"/>
    <p:sldId id="305" r:id="rId3"/>
    <p:sldId id="308" r:id="rId4"/>
    <p:sldId id="310" r:id="rId5"/>
    <p:sldId id="309" r:id="rId6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160" userDrawn="1">
          <p15:clr>
            <a:srgbClr val="A4A3A4"/>
          </p15:clr>
        </p15:guide>
        <p15:guide id="2" orient="horz" pos="2949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443ED59-20C7-4FDF-8DCA-8A14D1AA1C8C}" name="Microsoft Office User" initials="MOU" userId="Microsoft Office Use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89236"/>
    <a:srgbClr val="FF0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47" autoAdjust="0"/>
    <p:restoredTop sz="94660"/>
  </p:normalViewPr>
  <p:slideViewPr>
    <p:cSldViewPr snapToGrid="0">
      <p:cViewPr varScale="1">
        <p:scale>
          <a:sx n="75" d="100"/>
          <a:sy n="75" d="100"/>
        </p:scale>
        <p:origin x="2768" y="168"/>
      </p:cViewPr>
      <p:guideLst>
        <p:guide pos="2160"/>
        <p:guide orient="horz" pos="294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616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2795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060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0539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0536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571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218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39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0954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66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084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D48BD-BB6E-491B-BFCB-C86282FF85E8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B68BF-0336-4CE4-B47B-FF98670CDD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6828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6AF540F-0522-41B3-87D5-32CF1E1228EA}"/>
              </a:ext>
            </a:extLst>
          </p:cNvPr>
          <p:cNvSpPr txBox="1"/>
          <p:nvPr/>
        </p:nvSpPr>
        <p:spPr>
          <a:xfrm>
            <a:off x="2161056" y="487680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7EBA8399-E85B-4962-A6E2-90C7344899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9197434"/>
              </p:ext>
            </p:extLst>
          </p:nvPr>
        </p:nvGraphicFramePr>
        <p:xfrm>
          <a:off x="471487" y="3331936"/>
          <a:ext cx="5915026" cy="2520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5780">
                  <a:extLst>
                    <a:ext uri="{9D8B030D-6E8A-4147-A177-3AD203B41FA5}">
                      <a16:colId xmlns:a16="http://schemas.microsoft.com/office/drawing/2014/main" val="3876317447"/>
                    </a:ext>
                  </a:extLst>
                </a:gridCol>
                <a:gridCol w="1290551">
                  <a:extLst>
                    <a:ext uri="{9D8B030D-6E8A-4147-A177-3AD203B41FA5}">
                      <a16:colId xmlns:a16="http://schemas.microsoft.com/office/drawing/2014/main" val="694944231"/>
                    </a:ext>
                  </a:extLst>
                </a:gridCol>
                <a:gridCol w="1660987">
                  <a:extLst>
                    <a:ext uri="{9D8B030D-6E8A-4147-A177-3AD203B41FA5}">
                      <a16:colId xmlns:a16="http://schemas.microsoft.com/office/drawing/2014/main" val="3465056184"/>
                    </a:ext>
                  </a:extLst>
                </a:gridCol>
                <a:gridCol w="955964">
                  <a:extLst>
                    <a:ext uri="{9D8B030D-6E8A-4147-A177-3AD203B41FA5}">
                      <a16:colId xmlns:a16="http://schemas.microsoft.com/office/drawing/2014/main" val="221813345"/>
                    </a:ext>
                  </a:extLst>
                </a:gridCol>
                <a:gridCol w="1481744">
                  <a:extLst>
                    <a:ext uri="{9D8B030D-6E8A-4147-A177-3AD203B41FA5}">
                      <a16:colId xmlns:a16="http://schemas.microsoft.com/office/drawing/2014/main" val="3135491555"/>
                    </a:ext>
                  </a:extLst>
                </a:gridCol>
              </a:tblGrid>
              <a:tr h="3840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k</a:t>
                      </a:r>
                      <a:r>
                        <a:rPr lang="zh-CN" alt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ry/reg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lic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link str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4070348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oples r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2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750483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8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6146164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th kor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46657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p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6887513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1545076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ad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439064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1693027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07844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an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5609798"/>
                  </a:ext>
                </a:extLst>
              </a:tr>
              <a:tr h="2135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w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170" marR="7170" marT="71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1012119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id="{080843D1-09A0-42C9-91C5-3A1A44F0EA3C}"/>
              </a:ext>
            </a:extLst>
          </p:cNvPr>
          <p:cNvSpPr/>
          <p:nvPr/>
        </p:nvSpPr>
        <p:spPr>
          <a:xfrm>
            <a:off x="198121" y="2977609"/>
            <a:ext cx="64617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S1.  The top 10 countries/regions with most publications in the worl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4002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A3F649BF-5111-4257-BCA0-8E67834AF6D4}"/>
              </a:ext>
            </a:extLst>
          </p:cNvPr>
          <p:cNvSpPr/>
          <p:nvPr/>
        </p:nvSpPr>
        <p:spPr>
          <a:xfrm>
            <a:off x="228602" y="1878152"/>
            <a:ext cx="64617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S2.  Co-occurrence analysis of the top 25 keywords published by the top 3 countrie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4DF7373-BC36-4648-852D-4275DCC72F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6011072"/>
              </p:ext>
            </p:extLst>
          </p:nvPr>
        </p:nvGraphicFramePr>
        <p:xfrm>
          <a:off x="167640" y="2274888"/>
          <a:ext cx="6461759" cy="434784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26651">
                  <a:extLst>
                    <a:ext uri="{9D8B030D-6E8A-4147-A177-3AD203B41FA5}">
                      <a16:colId xmlns:a16="http://schemas.microsoft.com/office/drawing/2014/main" val="711148745"/>
                    </a:ext>
                  </a:extLst>
                </a:gridCol>
                <a:gridCol w="572509">
                  <a:extLst>
                    <a:ext uri="{9D8B030D-6E8A-4147-A177-3AD203B41FA5}">
                      <a16:colId xmlns:a16="http://schemas.microsoft.com/office/drawing/2014/main" val="107571117"/>
                    </a:ext>
                  </a:extLst>
                </a:gridCol>
                <a:gridCol w="333375">
                  <a:extLst>
                    <a:ext uri="{9D8B030D-6E8A-4147-A177-3AD203B41FA5}">
                      <a16:colId xmlns:a16="http://schemas.microsoft.com/office/drawing/2014/main" val="450667427"/>
                    </a:ext>
                  </a:extLst>
                </a:gridCol>
                <a:gridCol w="904875">
                  <a:extLst>
                    <a:ext uri="{9D8B030D-6E8A-4147-A177-3AD203B41FA5}">
                      <a16:colId xmlns:a16="http://schemas.microsoft.com/office/drawing/2014/main" val="2438279612"/>
                    </a:ext>
                  </a:extLst>
                </a:gridCol>
                <a:gridCol w="85725">
                  <a:extLst>
                    <a:ext uri="{9D8B030D-6E8A-4147-A177-3AD203B41FA5}">
                      <a16:colId xmlns:a16="http://schemas.microsoft.com/office/drawing/2014/main" val="944862505"/>
                    </a:ext>
                  </a:extLst>
                </a:gridCol>
                <a:gridCol w="621702">
                  <a:extLst>
                    <a:ext uri="{9D8B030D-6E8A-4147-A177-3AD203B41FA5}">
                      <a16:colId xmlns:a16="http://schemas.microsoft.com/office/drawing/2014/main" val="2962533254"/>
                    </a:ext>
                  </a:extLst>
                </a:gridCol>
                <a:gridCol w="285078">
                  <a:extLst>
                    <a:ext uri="{9D8B030D-6E8A-4147-A177-3AD203B41FA5}">
                      <a16:colId xmlns:a16="http://schemas.microsoft.com/office/drawing/2014/main" val="4058015532"/>
                    </a:ext>
                  </a:extLst>
                </a:gridCol>
                <a:gridCol w="1245870">
                  <a:extLst>
                    <a:ext uri="{9D8B030D-6E8A-4147-A177-3AD203B41FA5}">
                      <a16:colId xmlns:a16="http://schemas.microsoft.com/office/drawing/2014/main" val="2408457057"/>
                    </a:ext>
                  </a:extLst>
                </a:gridCol>
                <a:gridCol w="85725">
                  <a:extLst>
                    <a:ext uri="{9D8B030D-6E8A-4147-A177-3AD203B41FA5}">
                      <a16:colId xmlns:a16="http://schemas.microsoft.com/office/drawing/2014/main" val="1621932429"/>
                    </a:ext>
                  </a:extLst>
                </a:gridCol>
                <a:gridCol w="640191">
                  <a:extLst>
                    <a:ext uri="{9D8B030D-6E8A-4147-A177-3AD203B41FA5}">
                      <a16:colId xmlns:a16="http://schemas.microsoft.com/office/drawing/2014/main" val="1887706419"/>
                    </a:ext>
                  </a:extLst>
                </a:gridCol>
                <a:gridCol w="302895">
                  <a:extLst>
                    <a:ext uri="{9D8B030D-6E8A-4147-A177-3AD203B41FA5}">
                      <a16:colId xmlns:a16="http://schemas.microsoft.com/office/drawing/2014/main" val="1942936329"/>
                    </a:ext>
                  </a:extLst>
                </a:gridCol>
                <a:gridCol w="1057163">
                  <a:extLst>
                    <a:ext uri="{9D8B030D-6E8A-4147-A177-3AD203B41FA5}">
                      <a16:colId xmlns:a16="http://schemas.microsoft.com/office/drawing/2014/main" val="2691420932"/>
                    </a:ext>
                  </a:extLst>
                </a:gridCol>
              </a:tblGrid>
              <a:tr h="25876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a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th Kore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1384282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wor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wor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wor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9813914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n-US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US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51214593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ion</a:t>
                      </a:r>
                      <a:endParaRPr lang="en-US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cell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1405112619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east cancer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165250801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893108944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g delivery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501223252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294249800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t shock</a:t>
                      </a:r>
                      <a:endParaRPr lang="en-US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t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1623806571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induced arthriti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1690569564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g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therapy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523120943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 chaperone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451670346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kappa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490412752"/>
                  </a:ext>
                </a:extLst>
              </a:tr>
              <a:tr h="2484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ocellular carcin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sms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897208374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regu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zh-CN" sz="800" b="0" i="0" u="none" strike="noStrike" dirty="0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800" b="0" i="0" u="none" strike="noStrike">
                        <a:solidFill>
                          <a:srgbClr val="7030A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595149579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ig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vitr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692833281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vant 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ve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921297364"/>
                  </a:ext>
                </a:extLst>
              </a:tr>
              <a:tr h="2484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ve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vant induced 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plasmic reticulum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4055431657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iver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ory t cel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181796578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particl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oxidan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221402783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cel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expre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4294261337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s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ergy bala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grad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94552501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vitr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eumatoid 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xorubic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103287142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kappa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east canc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530416703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eumatoid 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de mi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589984916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 kappa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2642119620"/>
                  </a:ext>
                </a:extLst>
              </a:tr>
              <a:tr h="1470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es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ose tissu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70" marR="5070" marT="5070" marB="0" anchor="ctr"/>
                </a:tc>
                <a:extLst>
                  <a:ext uri="{0D108BD9-81ED-4DB2-BD59-A6C34878D82A}">
                    <a16:rowId xmlns:a16="http://schemas.microsoft.com/office/drawing/2014/main" val="35479991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28531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1C625D8A-F0C6-4616-A403-9B7D9D2170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1905699"/>
              </p:ext>
            </p:extLst>
          </p:nvPr>
        </p:nvGraphicFramePr>
        <p:xfrm>
          <a:off x="215900" y="1349375"/>
          <a:ext cx="6438901" cy="772437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93700">
                  <a:extLst>
                    <a:ext uri="{9D8B030D-6E8A-4147-A177-3AD203B41FA5}">
                      <a16:colId xmlns:a16="http://schemas.microsoft.com/office/drawing/2014/main" val="210111530"/>
                    </a:ext>
                  </a:extLst>
                </a:gridCol>
                <a:gridCol w="254336">
                  <a:extLst>
                    <a:ext uri="{9D8B030D-6E8A-4147-A177-3AD203B41FA5}">
                      <a16:colId xmlns:a16="http://schemas.microsoft.com/office/drawing/2014/main" val="4110234265"/>
                    </a:ext>
                  </a:extLst>
                </a:gridCol>
                <a:gridCol w="537464">
                  <a:extLst>
                    <a:ext uri="{9D8B030D-6E8A-4147-A177-3AD203B41FA5}">
                      <a16:colId xmlns:a16="http://schemas.microsoft.com/office/drawing/2014/main" val="3756766391"/>
                    </a:ext>
                  </a:extLst>
                </a:gridCol>
                <a:gridCol w="84500">
                  <a:extLst>
                    <a:ext uri="{9D8B030D-6E8A-4147-A177-3AD203B41FA5}">
                      <a16:colId xmlns:a16="http://schemas.microsoft.com/office/drawing/2014/main" val="532392932"/>
                    </a:ext>
                  </a:extLst>
                </a:gridCol>
                <a:gridCol w="622679">
                  <a:extLst>
                    <a:ext uri="{9D8B030D-6E8A-4147-A177-3AD203B41FA5}">
                      <a16:colId xmlns:a16="http://schemas.microsoft.com/office/drawing/2014/main" val="2312913438"/>
                    </a:ext>
                  </a:extLst>
                </a:gridCol>
                <a:gridCol w="583821">
                  <a:extLst>
                    <a:ext uri="{9D8B030D-6E8A-4147-A177-3AD203B41FA5}">
                      <a16:colId xmlns:a16="http://schemas.microsoft.com/office/drawing/2014/main" val="3600404685"/>
                    </a:ext>
                  </a:extLst>
                </a:gridCol>
                <a:gridCol w="736600">
                  <a:extLst>
                    <a:ext uri="{9D8B030D-6E8A-4147-A177-3AD203B41FA5}">
                      <a16:colId xmlns:a16="http://schemas.microsoft.com/office/drawing/2014/main" val="330182460"/>
                    </a:ext>
                  </a:extLst>
                </a:gridCol>
                <a:gridCol w="3225801">
                  <a:extLst>
                    <a:ext uri="{9D8B030D-6E8A-4147-A177-3AD203B41FA5}">
                      <a16:colId xmlns:a16="http://schemas.microsoft.com/office/drawing/2014/main" val="3194085699"/>
                    </a:ext>
                  </a:extLst>
                </a:gridCol>
              </a:tblGrid>
              <a:tr h="1886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lic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al link str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filiation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4945311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o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o, we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o, we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9512960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ang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qi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ang, luq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ang, luq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2723788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ou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iawei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ou, jiawe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ou, jiawe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9277583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, tianyu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, tianyu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, tianyu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0251913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, pi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, ping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, pi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852937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yifeng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yifeng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yife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8921557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g, yuru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g, yuru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g, yuru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8508850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o, yuju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o, yuju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o, yuju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0693149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u, yu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u, yu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u, yu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571418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, yu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, yu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, yu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7565930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ng, yad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ng, yad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ng, yad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197713"/>
                  </a:ext>
                </a:extLst>
              </a:tr>
              <a:tr h="18863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xiuju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iuju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xiuju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ital Medical University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8278673"/>
                  </a:ext>
                </a:extLst>
              </a:tr>
              <a:tr h="9593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0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——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5340680"/>
                  </a:ext>
                </a:extLst>
              </a:tr>
              <a:tr h="95939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6422817"/>
                  </a:ext>
                </a:extLst>
              </a:tr>
              <a:tr h="95939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4039092"/>
                  </a:ext>
                </a:extLst>
              </a:tr>
              <a:tr h="1886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lic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al link str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filiation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7771801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,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ingguo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, jinggu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0092252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ro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, zhanro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4811487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iga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jiga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5086093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f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f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2100504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o, zhihua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o, zhihu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8156548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junjie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junji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140302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ia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qi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5518531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u, le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u, le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Zhengzhou,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7290315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u, dand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u, dand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9384639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o, piao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o, pia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5285608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i, liuq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i, liuq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</a:t>
                      </a:r>
                      <a:r>
                        <a:rPr lang="zh-CN" alt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,</a:t>
                      </a:r>
                      <a:r>
                        <a:rPr lang="zh-CN" alt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5718200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uanbi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chuanb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 University,</a:t>
                      </a:r>
                      <a:r>
                        <a:rPr lang="zh-CN" alt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engzhou,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2749448"/>
                  </a:ext>
                </a:extLst>
              </a:tr>
              <a:tr h="17443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i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yi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a Academy of Chinese Medical Sciences, Beijing, Chi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697421"/>
                  </a:ext>
                </a:extLst>
              </a:tr>
              <a:tr h="9593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——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6193887"/>
                  </a:ext>
                </a:extLst>
              </a:tr>
              <a:tr h="95939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6952920"/>
                  </a:ext>
                </a:extLst>
              </a:tr>
              <a:tr h="95939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5781511"/>
                  </a:ext>
                </a:extLst>
              </a:tr>
              <a:tr h="1886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ho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blic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atio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al link str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filiation</a:t>
                      </a:r>
                      <a:endParaRPr 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0542728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nghai</a:t>
                      </a:r>
                      <a:endParaRPr lang="en-US" altLang="zh-CN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dengha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dengha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7644445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ying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ying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ng, yi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5692919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zan, georges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zan, georges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zan, george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972, Inserm, Hôpital Paul Brousse, Paris, France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0224934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g, b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g, b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g, b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4404519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xue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xue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ang, xu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1319106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o, fanf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o, fanf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o, fanf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6336034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u, lim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u, lim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u, lim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nghai Pudong Gongli Hospital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6596611"/>
                  </a:ext>
                </a:extLst>
              </a:tr>
              <a:tr h="9593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chunx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chunxi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chunx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dan University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9038334"/>
                  </a:ext>
                </a:extLst>
              </a:tr>
              <a:tr h="1744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ya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ya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ang, ya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 Military Medical University, Shanghai, Chi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4538167"/>
                  </a:ext>
                </a:extLst>
              </a:tr>
              <a:tr h="9593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——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5499761"/>
                  </a:ext>
                </a:extLst>
              </a:tr>
              <a:tr h="95939">
                <a:tc gridSpan="3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1" marR="4271" marT="42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7674659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D247E227-FC30-466E-8CF8-14FE94C58276}"/>
              </a:ext>
            </a:extLst>
          </p:cNvPr>
          <p:cNvSpPr/>
          <p:nvPr/>
        </p:nvSpPr>
        <p:spPr>
          <a:xfrm>
            <a:off x="734908" y="986147"/>
            <a:ext cx="55600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S3.  Cluster analysis of the Top 3 research teams focusing on celastro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95207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DCDF244B-D49E-44A1-BDD1-FC4378D041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1203196"/>
              </p:ext>
            </p:extLst>
          </p:nvPr>
        </p:nvGraphicFramePr>
        <p:xfrm>
          <a:off x="471487" y="1899997"/>
          <a:ext cx="6012001" cy="7200002"/>
        </p:xfrm>
        <a:graphic>
          <a:graphicData uri="http://schemas.openxmlformats.org/drawingml/2006/table">
            <a:tbl>
              <a:tblPr/>
              <a:tblGrid>
                <a:gridCol w="596798">
                  <a:extLst>
                    <a:ext uri="{9D8B030D-6E8A-4147-A177-3AD203B41FA5}">
                      <a16:colId xmlns:a16="http://schemas.microsoft.com/office/drawing/2014/main" val="3749367301"/>
                    </a:ext>
                  </a:extLst>
                </a:gridCol>
                <a:gridCol w="4584608">
                  <a:extLst>
                    <a:ext uri="{9D8B030D-6E8A-4147-A177-3AD203B41FA5}">
                      <a16:colId xmlns:a16="http://schemas.microsoft.com/office/drawing/2014/main" val="3491770747"/>
                    </a:ext>
                  </a:extLst>
                </a:gridCol>
                <a:gridCol w="264650">
                  <a:extLst>
                    <a:ext uri="{9D8B030D-6E8A-4147-A177-3AD203B41FA5}">
                      <a16:colId xmlns:a16="http://schemas.microsoft.com/office/drawing/2014/main" val="1810711213"/>
                    </a:ext>
                  </a:extLst>
                </a:gridCol>
                <a:gridCol w="565945">
                  <a:extLst>
                    <a:ext uri="{9D8B030D-6E8A-4147-A177-3AD203B41FA5}">
                      <a16:colId xmlns:a16="http://schemas.microsoft.com/office/drawing/2014/main" val="3743328475"/>
                    </a:ext>
                  </a:extLst>
                </a:gridCol>
              </a:tblGrid>
              <a:tr h="235251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ighly impacted references (left)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9385181"/>
                  </a:ext>
                </a:extLst>
              </a:tr>
              <a:tr h="2883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ank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ted Reference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itation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1928904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YANG HJ, 2006, CANCER RES, V66, P4758, DOI 10.1158/0008-5472.CAN-05-452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652752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IU JL, 2015, CELL, V161, P999, DOI 10.1016/J.CELL.2015.05.01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636454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ANNAIYAN R, 2011, CANCER LETT, V303, P9, DOI 10.1016/J.CANLET.2010.10.02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7543076"/>
                  </a:ext>
                </a:extLst>
              </a:tr>
              <a:tr h="2243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LLISON AC, 2001, PROG NEURO-PSYCHOPH, V25, P1341, DOI 10.1016/S0278-5846(01)00192-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055471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ALMINEN A, 2010, BIOCHEM BIOPH RES CO, V394, P439, DOI 10.1016/J.BBRC.2010.03.05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2046437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ETHI G, 2007, BLOOD, V109, P2727, DOI 10.1182/BLOOD-2006-10-050807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5376455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EE JH, 2006, BIOCHEM PHARMACOL, V72, P1311, DOI 10.1016/J.BCP.2006.08.01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1145099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WESTERHEIDE SD, 2004, J BIOL CHEM, V279, P56053, DOI 10.1074/JBC.M40926720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7912251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ANG XF, 2010, CANCER RES, V70, P1951, DOI 10.1158/0008-5472.CAN-09-320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717726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SCAO R, 2017, FRONT MED-LAUSANNE, V4, DOI 10.3389/FMED.2017.00069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5392785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5650114"/>
                  </a:ext>
                </a:extLst>
              </a:tr>
              <a:tr h="177639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ighly productive authors (middle)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526119"/>
                  </a:ext>
                </a:extLst>
              </a:tr>
              <a:tr h="2916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ank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uthor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rticle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rticle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875743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AO, WE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1140882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HANG, DENGHA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74385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WANG, YING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1773652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UANG, LUQI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182301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OUDGIL, KAMAL D.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988753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ZAN, GEORGES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431913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ENKATESHA, SHIVAPRASAD H.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4382913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HAO, Y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9437853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HOU, JIAWEI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4092911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EN, YAN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56237"/>
                  </a:ext>
                </a:extLst>
              </a:tr>
              <a:tr h="155349"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0452068"/>
                  </a:ext>
                </a:extLst>
              </a:tr>
              <a:tr h="210462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op 10 occurrence keywords (right)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1846487"/>
                  </a:ext>
                </a:extLst>
              </a:tr>
              <a:tr h="2630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ank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eyword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ccurrence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ccurrences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6991277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ctivatio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66231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lastrol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7490285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optosis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730878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xpressio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180977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lls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2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669730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f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kappa-b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1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7607963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rowth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0286729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hibitio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5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212076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-vitro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3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9373252"/>
                  </a:ext>
                </a:extLst>
              </a:tr>
              <a:tr h="178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nflammation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9</a:t>
                      </a:r>
                    </a:p>
                  </a:txBody>
                  <a:tcPr marL="5477" marR="5477" marT="54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7908891"/>
                  </a:ext>
                </a:extLst>
              </a:tr>
            </a:tbl>
          </a:graphicData>
        </a:graphic>
      </p:graphicFrame>
      <p:sp>
        <p:nvSpPr>
          <p:cNvPr id="4" name="矩形 3">
            <a:extLst>
              <a:ext uri="{FF2B5EF4-FFF2-40B4-BE49-F238E27FC236}">
                <a16:creationId xmlns:a16="http://schemas.microsoft.com/office/drawing/2014/main" id="{627BF301-404C-4C2A-B9D8-63F6A6AF7A77}"/>
              </a:ext>
            </a:extLst>
          </p:cNvPr>
          <p:cNvSpPr/>
          <p:nvPr/>
        </p:nvSpPr>
        <p:spPr>
          <a:xfrm>
            <a:off x="989327" y="1482675"/>
            <a:ext cx="50603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data of three-field plot (N = 10 item/plot) in Figure 4C</a:t>
            </a:r>
          </a:p>
        </p:txBody>
      </p:sp>
    </p:spTree>
    <p:extLst>
      <p:ext uri="{BB962C8B-B14F-4D97-AF65-F5344CB8AC3E}">
        <p14:creationId xmlns:p14="http://schemas.microsoft.com/office/powerpoint/2010/main" val="2328319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83B476B4-EB43-450A-9EA2-2D3B7428B2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2201532"/>
              </p:ext>
            </p:extLst>
          </p:nvPr>
        </p:nvGraphicFramePr>
        <p:xfrm>
          <a:off x="644769" y="1314944"/>
          <a:ext cx="5545016" cy="66138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3172">
                  <a:extLst>
                    <a:ext uri="{9D8B030D-6E8A-4147-A177-3AD203B41FA5}">
                      <a16:colId xmlns:a16="http://schemas.microsoft.com/office/drawing/2014/main" val="2348369103"/>
                    </a:ext>
                  </a:extLst>
                </a:gridCol>
                <a:gridCol w="1828248">
                  <a:extLst>
                    <a:ext uri="{9D8B030D-6E8A-4147-A177-3AD203B41FA5}">
                      <a16:colId xmlns:a16="http://schemas.microsoft.com/office/drawing/2014/main" val="781532174"/>
                    </a:ext>
                  </a:extLst>
                </a:gridCol>
                <a:gridCol w="1305892">
                  <a:extLst>
                    <a:ext uri="{9D8B030D-6E8A-4147-A177-3AD203B41FA5}">
                      <a16:colId xmlns:a16="http://schemas.microsoft.com/office/drawing/2014/main" val="2527860172"/>
                    </a:ext>
                  </a:extLst>
                </a:gridCol>
                <a:gridCol w="1707704">
                  <a:extLst>
                    <a:ext uri="{9D8B030D-6E8A-4147-A177-3AD203B41FA5}">
                      <a16:colId xmlns:a16="http://schemas.microsoft.com/office/drawing/2014/main" val="3846435866"/>
                    </a:ext>
                  </a:extLst>
                </a:gridCol>
              </a:tblGrid>
              <a:tr h="1818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wor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link str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162119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4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1012518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651760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946277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lamm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696869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023419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-kappa-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736172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237487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236260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-vitr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131153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ve 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574234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5515978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s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4571502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566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phag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3849292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esit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1872398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27740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particl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3654155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-regu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359834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14255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1189145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oxidan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9466042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217480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091332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868664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2893557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2739799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c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456727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029668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3376802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n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237327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sta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089487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ig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941983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tochondr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062038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6625148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601025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-expre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4817954"/>
                  </a:ext>
                </a:extLst>
              </a:tr>
              <a:tr h="18180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ocellular-carcin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8377664"/>
                  </a:ext>
                </a:extLst>
              </a:tr>
              <a:tr h="18180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eumatoid arthrit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293666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g-deliver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1545704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re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7143155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-regu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8679694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t-shoc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5374879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ct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1762925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availabilit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1640872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aling 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733994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6320860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5294873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3165409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90 inhibit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6038031"/>
                  </a:ext>
                </a:extLst>
              </a:tr>
              <a:tr h="1236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cer cel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505" marR="4505" marT="450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2191131"/>
                  </a:ext>
                </a:extLst>
              </a:tr>
            </a:tbl>
          </a:graphicData>
        </a:graphic>
      </p:graphicFrame>
      <p:sp>
        <p:nvSpPr>
          <p:cNvPr id="3" name="矩形 2">
            <a:extLst>
              <a:ext uri="{FF2B5EF4-FFF2-40B4-BE49-F238E27FC236}">
                <a16:creationId xmlns:a16="http://schemas.microsoft.com/office/drawing/2014/main" id="{9A2698AD-DF87-4E7C-8506-ED54FA69A538}"/>
              </a:ext>
            </a:extLst>
          </p:cNvPr>
          <p:cNvSpPr/>
          <p:nvPr/>
        </p:nvSpPr>
        <p:spPr>
          <a:xfrm>
            <a:off x="671408" y="986147"/>
            <a:ext cx="55600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S5.  Occurrences analysis of the Top 50 keywords on celastrol researc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01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63</TotalTime>
  <Words>1506</Words>
  <Application>Microsoft Macintosh PowerPoint</Application>
  <PresentationFormat>A4 纸张(210x297 毫米)</PresentationFormat>
  <Paragraphs>86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icrosoft Office User</cp:lastModifiedBy>
  <cp:revision>108</cp:revision>
  <dcterms:created xsi:type="dcterms:W3CDTF">2023-04-12T09:44:45Z</dcterms:created>
  <dcterms:modified xsi:type="dcterms:W3CDTF">2024-08-01T15:10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B580CFB827908C18D7D36645109ECEA</vt:lpwstr>
  </property>
  <property fmtid="{D5CDD505-2E9C-101B-9397-08002B2CF9AE}" pid="3" name="KSOProductBuildVer">
    <vt:lpwstr>2052-4.6.1.7467</vt:lpwstr>
  </property>
</Properties>
</file>